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191250" cy="29813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107A6-6BB6-4515-BDC9-2E73D94000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5572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9600" y="1723320"/>
            <a:ext cx="5572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A468EB-34DA-40EF-BBFC-B9141BBDBC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6512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9600" y="172332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65120" y="172332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75C7D-5A20-4D59-9149-FA34E907ED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93480" y="69480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77360" y="69480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9600" y="172332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93480" y="172332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77360" y="1723320"/>
            <a:ext cx="17938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71A92-C4DC-4BD9-AF96-9FF763E0B6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9600" y="694800"/>
            <a:ext cx="5572080" cy="1968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FB448-FCB0-4DAB-BE22-398EE3B6A6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5572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A2AFE-D078-4EB7-ABB1-99B8497944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2719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65120" y="694800"/>
            <a:ext cx="2719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4090F9-20EC-4B3B-A27F-B6CC3EA47A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5C769-0DAE-413B-B679-08B56A7958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9600" y="119160"/>
            <a:ext cx="5572080" cy="230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04981-0F7E-424C-B9E0-FB92AD5992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65120" y="694800"/>
            <a:ext cx="2719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9600" y="172332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9E770-7875-40EE-8B3E-13A0357FA6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2719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6512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65120" y="172332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C0032-B684-4FA5-A8AE-EE550C44DE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960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65120" y="694800"/>
            <a:ext cx="2719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9600" y="1723320"/>
            <a:ext cx="5572080" cy="9388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6ABD1-F4BE-4183-8F7A-56F4DD039B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9600" y="119160"/>
            <a:ext cx="5572080" cy="4968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9600" y="694800"/>
            <a:ext cx="5572080" cy="196884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 fontScale="84000"/>
          </a:bodyPr>
          <a:p>
            <a:pPr marL="163800" indent="-163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357120" indent="-1371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549360" indent="-1094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768960" indent="-109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989280" indent="-10944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989280" indent="-10944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989280" indent="-10944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9240" y="2763360"/>
            <a:ext cx="1444680" cy="1587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lstStyle>
            <a:lvl1pPr indent="0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  <a:defRPr b="0" lang="fr-FR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fld id="{7F86A781-4EEF-4AB3-96C7-DAFB409F1F3C}" type="datetime">
              <a:rPr b="0" lang="fr-FR" sz="7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16080" y="2763360"/>
            <a:ext cx="1960560" cy="1587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36640" y="2763360"/>
            <a:ext cx="1444680" cy="1587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lstStyle>
            <a:lvl1pPr indent="0" algn="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  <a:defRPr b="0" lang="fr-FR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fld id="{7ED6DBAE-7F3A-472B-882A-7DD5D6631725}" type="slidenum">
              <a:rPr b="0" lang="fr-FR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9360" y="-3240"/>
            <a:ext cx="6172200" cy="29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EcClpP      </a:t>
            </a:r>
            <a:r>
              <a:rPr b="1" lang="fr-FR" sz="1000" spc="-1" strike="noStrike">
                <a:solidFill>
                  <a:srgbClr val="000000"/>
                </a:solidFill>
                <a:latin typeface="Monaco"/>
              </a:rPr>
              <a:t>MSYSGERDNFAPHM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ALVPMVIEQTSRGERSFDIYSRLLKERVIFLTGQVEDHMANLIVAQ 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1     -------------MSQVTDMRSNSQGLSLTDSVYERLLSERIIFLGSEVNDEIANRLCAQ 4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2     -MNSQNSQIQPQARYILPSFIEHSSFGVKESNPYNKLFEERIIFLGVQVDDASANDIMAQ 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                            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:. . .::.      . *.:*:.**:***  :*:*  ** : 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EcClpP      MLFLEAENPEKDIYLYINSPGGVITAGMSIYDTMQFIKPDVSTICMGQAA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S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MGAFLLTAG 1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1     ILLLAAEDASKDISLYINSPGGSISAGMAIYDTMVLAPCDIATYAMGMAA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S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MGEFLLAAG 10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2     LLVLESLDPDRDITMYINSPGGGFTSLMAIYDTMQYVRADIQTVCLGQAA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S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AAAVLLAAG 11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            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:*.* : :..:** :******* ::: *:*****     *: * .:* *** . .**: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EcClpP      AKGKRFCLPNSRVMI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H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QP--LGGYQGQATDIEIHAREILKVKGRMNELMALHTGQSLEQI 17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1     TKGKRYALPHARILM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H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QP--LGGVTGSAADIAIQAEQFAVIKKEMFRLNAEFTGQPIERI 1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2     TPGKRMALPNARVLI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H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QPSLSGVIQGQFSDLEIQAAEIERMRTLMETTLARHTGKDAGVI 17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            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: *** .**::*:::***   *   *. :*: *:* ::  ::  *    * .**:    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EcClpP      ERDTER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D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RFLSAPEAVEYGLVDSILT--HRN---- 20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1     EADSDR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D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RWFTAAEALEYGFVDHIITRAHVNGEAQ 2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TBClpP2     RKDTDR</a:t>
            </a:r>
            <a:r>
              <a:rPr b="1" lang="fr-FR" sz="1000" spc="-1" strike="noStrike" u="sng">
                <a:solidFill>
                  <a:srgbClr val="000000"/>
                </a:solidFill>
                <a:uFillTx/>
                <a:latin typeface="Monaco"/>
              </a:rPr>
              <a:t>D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KILTAEEAKDYGIIDTVLEYRKLSAQTA 2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262080"/>
                <a:tab algn="l" pos="523800"/>
                <a:tab algn="l" pos="785880"/>
                <a:tab algn="l" pos="1047600"/>
                <a:tab algn="l" pos="1309680"/>
                <a:tab algn="l" pos="1571760"/>
                <a:tab algn="l" pos="1833480"/>
                <a:tab algn="l" pos="2095560"/>
                <a:tab algn="l" pos="2357280"/>
                <a:tab algn="l" pos="2619360"/>
                <a:tab algn="l" pos="2881440"/>
                <a:tab algn="l" pos="3143160"/>
                <a:tab algn="l" pos="3405240"/>
                <a:tab algn="l" pos="3666960"/>
                <a:tab algn="l" pos="3929040"/>
                <a:tab algn="l" pos="4191120"/>
                <a:tab algn="l" pos="4452840"/>
                <a:tab algn="l" pos="4714920"/>
                <a:tab algn="l" pos="4976640"/>
                <a:tab algn="l" pos="523872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            </a:t>
            </a:r>
            <a:r>
              <a:rPr b="0" lang="fr-FR" sz="1000" spc="-1" strike="noStrike">
                <a:solidFill>
                  <a:srgbClr val="000000"/>
                </a:solidFill>
                <a:latin typeface="Monaco"/>
              </a:rPr>
              <a:t>. *::**: ::* ** :**::* ::   : .   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31T20:48:32Z</dcterms:created>
  <dc:creator>Nadia</dc:creator>
  <dc:description/>
  <dc:language>en-US</dc:language>
  <cp:lastModifiedBy>Nadia</cp:lastModifiedBy>
  <dcterms:modified xsi:type="dcterms:W3CDTF">2011-11-03T19:48:54Z</dcterms:modified>
  <cp:revision>2</cp:revision>
  <dc:subject/>
  <dc:title>Diapositive 1</dc:title>
</cp:coreProperties>
</file>